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heme/theme2.xml" ContentType="application/vnd.openxmlformats-officedocument.theme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416" r:id="rId2"/>
  </p:sldIdLst>
  <p:sldSz cx="12801600" cy="9601200" type="A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03">
          <p15:clr>
            <a:srgbClr val="A4A3A4"/>
          </p15:clr>
        </p15:guide>
        <p15:guide id="2" pos="4026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778" autoAdjust="0"/>
    <p:restoredTop sz="94660"/>
  </p:normalViewPr>
  <p:slideViewPr>
    <p:cSldViewPr snapToGrid="0">
      <p:cViewPr varScale="1">
        <p:scale>
          <a:sx n="56" d="100"/>
          <a:sy n="56" d="100"/>
        </p:scale>
        <p:origin x="43" y="130"/>
      </p:cViewPr>
      <p:guideLst>
        <p:guide orient="horz" pos="3003"/>
        <p:guide pos="4026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r>
              <a:rPr lang="en-US" altLang="zh-CN"/>
              <a:t>Almost all species in the figure just have the Nvd, EcR, RXR. The five gastropoda species show have the CYP18A1-like, (CYP18a1 encodes the ecdysteroid 26-hydroxylase, a major hormone inactivation enzyme. ) (Later will update the ML tree) seems like that may have different function and also reveals the evolutionary. the two Plathelminthes species don’t have the Nvd and EcR.</a:t>
            </a: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2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1258740" y="1280160"/>
            <a:ext cx="10289161" cy="359856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84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1258740" y="4984560"/>
            <a:ext cx="10289161" cy="206136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3360" spc="200"/>
            </a:lvl1pPr>
            <a:lvl2pPr marL="640080" indent="0" algn="ctr">
              <a:buNone/>
              <a:defRPr sz="2800"/>
            </a:lvl2pPr>
            <a:lvl3pPr marL="1280160" indent="0" algn="ctr">
              <a:buNone/>
              <a:defRPr sz="2520"/>
            </a:lvl3pPr>
            <a:lvl4pPr marL="1920240" indent="0" algn="ctr">
              <a:buNone/>
              <a:defRPr sz="2240"/>
            </a:lvl4pPr>
            <a:lvl5pPr marL="2560320" indent="0" algn="ctr">
              <a:buNone/>
              <a:defRPr sz="2240"/>
            </a:lvl5pPr>
            <a:lvl6pPr marL="3200400" indent="0" algn="ctr">
              <a:buNone/>
              <a:defRPr sz="2240"/>
            </a:lvl6pPr>
            <a:lvl7pPr marL="3840480" indent="0" algn="ctr">
              <a:buNone/>
              <a:defRPr sz="2240"/>
            </a:lvl7pPr>
            <a:lvl8pPr marL="4480560" indent="0" algn="ctr">
              <a:buNone/>
              <a:defRPr sz="2240"/>
            </a:lvl8pPr>
            <a:lvl9pPr marL="5120640" indent="0" algn="ctr">
              <a:buNone/>
              <a:defRPr sz="224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638820" y="1083600"/>
            <a:ext cx="11521441" cy="767592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1258740" y="3477600"/>
            <a:ext cx="10289161" cy="142632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8400"/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1258740" y="4984560"/>
            <a:ext cx="10289161" cy="66024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336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38820" y="851760"/>
            <a:ext cx="11517661" cy="98784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638820" y="2086560"/>
            <a:ext cx="11517661" cy="666288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2090340" y="5387760"/>
            <a:ext cx="8157241" cy="107352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616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2090340" y="6461280"/>
            <a:ext cx="8157241" cy="121464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252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64008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38820" y="851760"/>
            <a:ext cx="11517661" cy="98784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638820" y="2101680"/>
            <a:ext cx="5435641" cy="664776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732181" y="2101680"/>
            <a:ext cx="5435641" cy="664776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38820" y="851760"/>
            <a:ext cx="11517661" cy="98784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638820" y="2000880"/>
            <a:ext cx="5609521" cy="53424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8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38820" y="2595600"/>
            <a:ext cx="5609521" cy="615384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6547538" y="1990421"/>
            <a:ext cx="5609521" cy="53424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8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6547538" y="2595600"/>
            <a:ext cx="5609521" cy="615384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38820" y="851760"/>
            <a:ext cx="11517661" cy="98784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638820" y="2177280"/>
            <a:ext cx="5494731" cy="64512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2240"/>
            </a:lvl1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6667921" y="2177280"/>
            <a:ext cx="5488561" cy="64512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2240"/>
            </a:lvl1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1/5/26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10746541" y="1280160"/>
            <a:ext cx="1096200" cy="704088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3920"/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960120" y="1280160"/>
            <a:ext cx="9627661" cy="7040880"/>
          </a:xfrm>
        </p:spPr>
        <p:txBody>
          <a:bodyPr vert="eaVert" lIns="46800" tIns="46800" rIns="46800" bIns="46800"/>
          <a:lstStyle>
            <a:lvl1pPr marL="320040" indent="-320040">
              <a:spcAft>
                <a:spcPts val="1000"/>
              </a:spcAft>
              <a:defRPr spc="300"/>
            </a:lvl1pPr>
            <a:lvl2pPr marL="960120" indent="-320040">
              <a:defRPr spc="300"/>
            </a:lvl2pPr>
            <a:lvl3pPr marL="1600200" indent="-320040">
              <a:defRPr spc="300"/>
            </a:lvl3pPr>
            <a:lvl4pPr marL="2240280" indent="-320040">
              <a:defRPr spc="300"/>
            </a:lvl4pPr>
            <a:lvl5pPr marL="2880360" indent="-32004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638820" y="851760"/>
            <a:ext cx="11517661" cy="98784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638820" y="2086560"/>
            <a:ext cx="11517661" cy="666288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642600" y="8840160"/>
            <a:ext cx="2835000" cy="4435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4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4321800" y="8840160"/>
            <a:ext cx="4158000" cy="4435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4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9321481" y="8840160"/>
            <a:ext cx="2835000" cy="4435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4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280160" rtl="0" eaLnBrk="1" fontAlgn="auto" latinLnBrk="0" hangingPunct="1">
        <a:lnSpc>
          <a:spcPct val="100000"/>
        </a:lnSpc>
        <a:spcBef>
          <a:spcPct val="0"/>
        </a:spcBef>
        <a:buNone/>
        <a:defRPr sz="504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320040" indent="-320040" algn="l" defTabSz="128016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252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960120" indent="-320040" algn="l" defTabSz="128016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2253615" algn="l"/>
          <a:tab pos="2253615" algn="l"/>
          <a:tab pos="2253615" algn="l"/>
          <a:tab pos="2253615" algn="l"/>
        </a:tabLst>
        <a:defRPr sz="224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1600200" indent="-320040" algn="l" defTabSz="128016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224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2240280" indent="-320040" algn="l" defTabSz="128016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96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2880360" indent="-320040" algn="l" defTabSz="128016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96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352044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64.xml"/><Relationship Id="rId1" Type="http://schemas.openxmlformats.org/officeDocument/2006/relationships/tags" Target="../tags/tag63.xml"/><Relationship Id="rId4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/>
          <p:nvPr>
            <p:custDataLst>
              <p:tags r:id="rId2"/>
            </p:custDataLst>
            <p:extLst>
              <p:ext uri="{D42A27DB-BD31-4B8C-83A1-F6EECF244321}">
                <p14:modId xmlns:p14="http://schemas.microsoft.com/office/powerpoint/2010/main" val="2919069936"/>
              </p:ext>
            </p:extLst>
          </p:nvPr>
        </p:nvGraphicFramePr>
        <p:xfrm>
          <a:off x="129540" y="52781"/>
          <a:ext cx="12642850" cy="962977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0266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7452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9639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5598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4074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7345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9408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7947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80073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1212215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712595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</a:tblGrid>
              <a:tr h="51562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Gene name</a:t>
                      </a:r>
                    </a:p>
                    <a:p>
                      <a:pPr indent="0" algn="ctr">
                        <a:buNone/>
                      </a:pPr>
                      <a:endParaRPr lang="en-US" sz="12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  <a:p>
                      <a:pPr indent="0" algn="ctr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bbreviation</a:t>
                      </a:r>
                      <a:endParaRPr lang="en-US" altLang="en-US" sz="12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holesterol 7-desaturase</a:t>
                      </a:r>
                    </a:p>
                    <a:p>
                      <a:pPr indent="0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(Neverland) </a:t>
                      </a:r>
                    </a:p>
                    <a:p>
                      <a:pPr indent="0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Nvd</a:t>
                      </a:r>
                      <a:endParaRPr lang="en-US" altLang="en-US" sz="12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pook</a:t>
                      </a:r>
                    </a:p>
                    <a:p>
                      <a:pPr indent="0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(</a:t>
                      </a: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YP307A1</a:t>
                      </a: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)</a:t>
                      </a:r>
                    </a:p>
                    <a:p>
                      <a:pPr indent="0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po</a:t>
                      </a:r>
                      <a:endParaRPr lang="en-US" altLang="en-US" sz="12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phantom (CYP306A1)</a:t>
                      </a:r>
                    </a:p>
                    <a:p>
                      <a:pPr indent="0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Phm</a:t>
                      </a:r>
                      <a:endParaRPr lang="en-US" altLang="en-US" sz="12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disembodied</a:t>
                      </a:r>
                    </a:p>
                    <a:p>
                      <a:pPr indent="0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(</a:t>
                      </a: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YP302A1</a:t>
                      </a: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)</a:t>
                      </a:r>
                    </a:p>
                    <a:p>
                      <a:pPr indent="0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Dib</a:t>
                      </a:r>
                      <a:endParaRPr lang="en-US" altLang="en-US" sz="12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hadow</a:t>
                      </a:r>
                    </a:p>
                    <a:p>
                      <a:pPr indent="0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(</a:t>
                      </a: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YP315A1</a:t>
                      </a: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)</a:t>
                      </a:r>
                    </a:p>
                    <a:p>
                      <a:pPr indent="0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ad</a:t>
                      </a:r>
                      <a:endParaRPr lang="en-US" altLang="en-US" sz="12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hade</a:t>
                      </a:r>
                    </a:p>
                    <a:p>
                      <a:pPr indent="0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(</a:t>
                      </a: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YP314A1</a:t>
                      </a: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)</a:t>
                      </a:r>
                    </a:p>
                    <a:p>
                      <a:pPr indent="0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hd</a:t>
                      </a:r>
                      <a:endParaRPr lang="en-US" altLang="en-US" sz="12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YP18A1</a:t>
                      </a:r>
                      <a:endParaRPr lang="en-US" altLang="en-US" sz="12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Ecdysone receptor </a:t>
                      </a:r>
                    </a:p>
                    <a:p>
                      <a:pPr indent="0">
                        <a:buNone/>
                      </a:pPr>
                      <a:endParaRPr lang="en-US" sz="12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  <a:p>
                      <a:pPr indent="0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EcR</a:t>
                      </a:r>
                      <a:endParaRPr lang="en-US" altLang="en-US" sz="12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Retinoid X receptor/ultraspiracle  RXR</a:t>
                      </a:r>
                      <a:endParaRPr lang="en-US" altLang="en-US" sz="12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>
                    <a:lnL>
                      <a:noFill/>
                    </a:lnL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24180">
                <a:tc rowSpan="12"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Gastropoda</a:t>
                      </a:r>
                      <a:endParaRPr lang="en-US" altLang="en-US" sz="1200" b="1">
                        <a:solidFill>
                          <a:srgbClr val="2E2E2E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 dirty="0" err="1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Biomphalaria</a:t>
                      </a:r>
                      <a:r>
                        <a:rPr lang="en-US" sz="1200" b="1" i="1" dirty="0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 </a:t>
                      </a:r>
                      <a:r>
                        <a:rPr lang="en-US" sz="1200" b="1" i="1" dirty="0" err="1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straminea</a:t>
                      </a:r>
                      <a:endParaRPr lang="en-US" altLang="en-US" sz="1200" b="1" i="1" dirty="0">
                        <a:solidFill>
                          <a:srgbClr val="2E2E2E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Times New Roman" panose="02020603050405020304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Times New Roman" panose="02020603050405020304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Times New Roman" panose="02020603050405020304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Times New Roman" panose="02020603050405020304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892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 dirty="0" err="1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Biomphalaria</a:t>
                      </a:r>
                      <a:r>
                        <a:rPr lang="en-US" sz="1200" b="1" i="1" dirty="0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 glabrata</a:t>
                      </a:r>
                      <a:endParaRPr lang="en-US" altLang="en-US" sz="1200" b="1" i="1" dirty="0">
                        <a:solidFill>
                          <a:srgbClr val="2E2E2E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Times New Roman" panose="02020603050405020304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Times New Roman" panose="02020603050405020304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Times New Roman" panose="02020603050405020304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Times New Roman" panose="02020603050405020304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70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 dirty="0" err="1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Haliotis</a:t>
                      </a:r>
                      <a:r>
                        <a:rPr lang="en-US" sz="1200" b="1" i="1" dirty="0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 discus</a:t>
                      </a:r>
                      <a:endParaRPr lang="en-US" altLang="en-US" sz="1200" b="1" i="1" dirty="0">
                        <a:solidFill>
                          <a:srgbClr val="2E2E2E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892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 dirty="0" err="1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Lottia</a:t>
                      </a:r>
                      <a:r>
                        <a:rPr lang="en-US" sz="1200" b="1" i="1" dirty="0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 gigantea</a:t>
                      </a:r>
                      <a:endParaRPr lang="en-US" altLang="en-US" sz="1200" b="1" i="1" dirty="0">
                        <a:solidFill>
                          <a:srgbClr val="2E2E2E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82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 dirty="0" err="1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Lanistes</a:t>
                      </a:r>
                      <a:r>
                        <a:rPr lang="en-US" sz="1200" b="1" i="1" dirty="0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 </a:t>
                      </a:r>
                      <a:r>
                        <a:rPr lang="en-US" sz="1200" b="1" i="1" dirty="0" err="1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nyassanus</a:t>
                      </a:r>
                      <a:endParaRPr lang="en-US" altLang="en-US" sz="1200" b="1" i="1" dirty="0">
                        <a:solidFill>
                          <a:srgbClr val="2E2E2E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8892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 dirty="0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Marisa </a:t>
                      </a:r>
                      <a:r>
                        <a:rPr lang="en-US" sz="1200" b="1" i="1" dirty="0" err="1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cornuarietis</a:t>
                      </a:r>
                      <a:endParaRPr lang="en-US" altLang="en-US" sz="1200" b="1" i="1" dirty="0">
                        <a:solidFill>
                          <a:srgbClr val="2E2E2E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876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Pomacea canaliculata</a:t>
                      </a:r>
                      <a:endParaRPr lang="en-US" altLang="en-US" sz="1200" b="1" i="1">
                        <a:solidFill>
                          <a:srgbClr val="2E2E2E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882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 dirty="0" err="1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Pomacea</a:t>
                      </a:r>
                      <a:r>
                        <a:rPr lang="en-US" sz="1200" b="1" i="1" dirty="0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 </a:t>
                      </a:r>
                      <a:r>
                        <a:rPr lang="en-US" sz="1200" b="1" i="1" dirty="0" err="1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maculata</a:t>
                      </a:r>
                      <a:endParaRPr lang="en-US" altLang="en-US" sz="1200" b="1" i="1" dirty="0">
                        <a:solidFill>
                          <a:srgbClr val="2E2E2E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8892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Radix auricularia</a:t>
                      </a:r>
                      <a:endParaRPr lang="en-US" altLang="en-US" sz="1200" b="1" i="1">
                        <a:solidFill>
                          <a:srgbClr val="2E2E2E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632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Chrysomallon squamiferum</a:t>
                      </a:r>
                      <a:endParaRPr lang="en-US" altLang="en-US" sz="1200" b="1" i="1">
                        <a:solidFill>
                          <a:srgbClr val="2E2E2E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876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 dirty="0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Achatina </a:t>
                      </a:r>
                      <a:r>
                        <a:rPr lang="en-US" sz="1200" b="1" i="1" dirty="0" err="1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fulica</a:t>
                      </a:r>
                      <a:endParaRPr lang="en-US" altLang="en-US" sz="1200" b="1" i="1" dirty="0">
                        <a:solidFill>
                          <a:srgbClr val="2E2E2E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993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>
                          <a:solidFill>
                            <a:srgbClr val="2E2E2E"/>
                          </a:solidFill>
                          <a:latin typeface="Times New Roman" panose="02020603050405020304" charset="-122"/>
                        </a:rPr>
                        <a:t>Achatina immaculata</a:t>
                      </a:r>
                      <a:endParaRPr lang="en-US" altLang="en-US" sz="1200" b="1" i="1">
                        <a:solidFill>
                          <a:srgbClr val="2E2E2E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alt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88925">
                <a:tc rowSpan="11"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Bivalvia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Magallana hongkongensis</a:t>
                      </a:r>
                      <a:endParaRPr lang="en-US" altLang="en-US" sz="12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870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rassostrea gigas</a:t>
                      </a:r>
                      <a:endParaRPr lang="en-US" altLang="en-US" sz="12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882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rassostrea virginica</a:t>
                      </a:r>
                      <a:endParaRPr lang="en-US" altLang="en-US" sz="12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8892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accostrea glomerata</a:t>
                      </a:r>
                      <a:endParaRPr lang="en-US" altLang="en-US" sz="1200" b="1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8892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Bathymodiolus platifrons</a:t>
                      </a:r>
                      <a:endParaRPr lang="en-US" altLang="en-US" sz="12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870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Modiolus philippinarum</a:t>
                      </a:r>
                      <a:endParaRPr lang="en-US" altLang="en-US" sz="12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8892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Pinctada fucata</a:t>
                      </a:r>
                      <a:endParaRPr lang="en-US" altLang="en-US" sz="12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8892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P. f.  </a:t>
                      </a:r>
                      <a:r>
                        <a:rPr lang="en-US" sz="1200" b="1" i="1" dirty="0" err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martensii</a:t>
                      </a:r>
                      <a:endParaRPr lang="en-US" altLang="en-US" sz="1200" b="1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870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 dirty="0" err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Mizuhopecten</a:t>
                      </a:r>
                      <a:r>
                        <a:rPr lang="en-US" sz="1200" b="1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 </a:t>
                      </a:r>
                      <a:r>
                        <a:rPr lang="en-US" sz="1200" b="1" i="1" dirty="0" err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yessoensis</a:t>
                      </a:r>
                      <a:endParaRPr lang="en-US" altLang="en-US" sz="1200" b="1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882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 dirty="0" err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yclina</a:t>
                      </a:r>
                      <a:r>
                        <a:rPr lang="en-US" sz="1200" b="1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 sinensis</a:t>
                      </a:r>
                      <a:endParaRPr lang="en-US" altLang="en-US" sz="1200" b="1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3632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capharca (Anadara) broughtonii</a:t>
                      </a:r>
                      <a:endParaRPr lang="en-US" altLang="en-US" sz="12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88290">
                <a:tc rowSpan="3"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ephalopoda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Octopus </a:t>
                      </a:r>
                      <a:r>
                        <a:rPr lang="en-US" sz="1200" b="1" i="1" dirty="0" err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bimaculoides</a:t>
                      </a:r>
                      <a:endParaRPr lang="en-US" altLang="en-US" sz="1200" b="1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876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rchiteuthis dux(squid)</a:t>
                      </a:r>
                      <a:endParaRPr lang="en-US" altLang="en-US" sz="12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28892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Octopus sinensis</a:t>
                      </a:r>
                      <a:endParaRPr lang="en-US" altLang="en-US" sz="1200" b="1" i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287655">
                <a:tc rowSpan="2"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Annelida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 dirty="0" err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Helobdella</a:t>
                      </a:r>
                      <a:r>
                        <a:rPr lang="en-US" sz="1200" b="1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 </a:t>
                      </a:r>
                      <a:r>
                        <a:rPr lang="en-US" sz="1200" b="1" i="1" dirty="0" err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robusta</a:t>
                      </a:r>
                      <a:endParaRPr lang="en-US" altLang="en-US" sz="1200" b="1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2882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B cap="flat"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Capitella </a:t>
                      </a:r>
                      <a:r>
                        <a:rPr lang="en-US" sz="1200" b="1" i="1" dirty="0" err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teleta</a:t>
                      </a:r>
                      <a:endParaRPr lang="en-US" altLang="en-US" sz="1200" b="1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363220">
                <a:tc rowSpan="2"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Plathelminthes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Echinococcus </a:t>
                      </a:r>
                      <a:r>
                        <a:rPr lang="en-US" sz="1200" b="1" i="1" dirty="0" err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multilocularis</a:t>
                      </a:r>
                      <a:endParaRPr lang="en-US" altLang="en-US" sz="1200" b="1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28892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i="1" dirty="0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Schistosoma </a:t>
                      </a:r>
                      <a:r>
                        <a:rPr lang="en-US" sz="1200" b="1" i="1" dirty="0" err="1">
                          <a:solidFill>
                            <a:srgbClr val="000000"/>
                          </a:solidFill>
                          <a:latin typeface="Times New Roman" panose="02020603050405020304" charset="-122"/>
                        </a:rPr>
                        <a:t>mansoni</a:t>
                      </a:r>
                      <a:endParaRPr lang="en-US" altLang="en-US" sz="1200" b="1" i="1" dirty="0">
                        <a:solidFill>
                          <a:srgbClr val="000000"/>
                        </a:solidFill>
                        <a:latin typeface="Times New Roman" panose="020206030504050203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-</a:t>
                      </a:r>
                      <a:endParaRPr lang="en-US" altLang="en-US" sz="1200" b="1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 dirty="0">
                          <a:solidFill>
                            <a:srgbClr val="FF0000"/>
                          </a:solidFill>
                          <a:latin typeface="宋体" panose="02010600030101010101" pitchFamily="2" charset="-122"/>
                        </a:rPr>
                        <a:t>+</a:t>
                      </a:r>
                      <a:endParaRPr lang="en-US" altLang="en-US" sz="1200" b="1" dirty="0">
                        <a:solidFill>
                          <a:srgbClr val="FF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</a:tbl>
          </a:graphicData>
        </a:graphic>
      </p:graphicFrame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fdea4440-2b9b-42de-a870-561793e8d68b}"/>
  <p:tag name="TABLE_ENDDRAG_ORIGIN_RECT" val="995*748"/>
  <p:tag name="TABLE_ENDDRAG_RECT" val="10*4*995*748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458</Words>
  <Application>Microsoft Office PowerPoint</Application>
  <PresentationFormat>A3 Paper (297x420 mm)</PresentationFormat>
  <Paragraphs>33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Times New Roman</vt:lpstr>
      <vt:lpstr>Wingdings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Jerome Hui</cp:lastModifiedBy>
  <cp:revision>162</cp:revision>
  <dcterms:created xsi:type="dcterms:W3CDTF">2019-06-19T02:08:00Z</dcterms:created>
  <dcterms:modified xsi:type="dcterms:W3CDTF">2021-05-26T12:16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463</vt:lpwstr>
  </property>
  <property fmtid="{D5CDD505-2E9C-101B-9397-08002B2CF9AE}" pid="3" name="ICV">
    <vt:lpwstr>F827B9B2C0CF4B78826EF9D4246A0E34</vt:lpwstr>
  </property>
</Properties>
</file>